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76" r:id="rId3"/>
    <p:sldId id="257" r:id="rId4"/>
    <p:sldId id="258" r:id="rId5"/>
    <p:sldId id="282" r:id="rId6"/>
    <p:sldId id="283" r:id="rId7"/>
    <p:sldId id="280" r:id="rId8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9" d="100"/>
          <a:sy n="59" d="100"/>
        </p:scale>
        <p:origin x="96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9CC0D27-8827-05E7-9C28-D29E5D31066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5ADFA342-6907-67F5-E0BD-C2049B63480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EDB2997-D688-7FEF-3D22-DFFD1372E3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6A689-F3CE-432A-A9BA-4A41827DEE15}" type="datetimeFigureOut">
              <a:rPr lang="fr-FR" smtClean="0"/>
              <a:t>15/06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ECE7B26-77D7-B1FB-EAF9-3FA26DBFB4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55F8642-EFFC-EFC4-36AF-38BCFE2D44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09C14-0F56-452B-9D10-54A08F0492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201582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28E205A-5060-74A1-3B61-2386FDCA92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7AE773E6-12D3-D8A8-857D-3067DBE40C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A44F6D2-791E-3936-6195-DF077C42A8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6A689-F3CE-432A-A9BA-4A41827DEE15}" type="datetimeFigureOut">
              <a:rPr lang="fr-FR" smtClean="0"/>
              <a:t>15/06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ED2C8D2-EAE8-9462-09BD-B41ABB4E17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8C00F78-213C-8E45-B309-2F59092FC5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09C14-0F56-452B-9D10-54A08F0492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22364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79D7BD92-C3CE-E099-FBFE-E4A3D6FEAE7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01D11CD6-07D0-E523-DE59-B414570B04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F664CE4-7B4B-8FEC-1D55-9437A2BE18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6A689-F3CE-432A-A9BA-4A41827DEE15}" type="datetimeFigureOut">
              <a:rPr lang="fr-FR" smtClean="0"/>
              <a:t>15/06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BD7DE77-858D-F1F4-4391-19A2BE61B4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0664E4D-3A0C-FEFB-86E6-1F0451FDB4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09C14-0F56-452B-9D10-54A08F0492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457641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E316256-179E-BD6B-3382-FD7A2258BB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015429D-53A3-9D93-C1BE-70B20BD0483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E87B6FE-0417-892F-1E61-0C5037356D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6A689-F3CE-432A-A9BA-4A41827DEE15}" type="datetimeFigureOut">
              <a:rPr lang="fr-FR" smtClean="0"/>
              <a:t>15/06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A2DBD43-BFF5-4865-C43B-5F21E0425C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62C16B1-3C53-2830-EC54-12722B73EE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09C14-0F56-452B-9D10-54A08F0492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77206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B8C2D19-B557-15D8-93EA-00A422BA92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6743C5AC-A16F-C254-1ABF-734DEDE552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A05A742-0A45-ACA1-5BDF-2ED6FCE35A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6A689-F3CE-432A-A9BA-4A41827DEE15}" type="datetimeFigureOut">
              <a:rPr lang="fr-FR" smtClean="0"/>
              <a:t>15/06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AC4AB9F-2AB5-4DCC-8571-CF12213192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E2D7497-6DF5-3142-B74C-8D03EDE3A5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09C14-0F56-452B-9D10-54A08F0492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38663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C4C4153-C22E-6015-F0E9-F6E2B91053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A9896C5-AEAD-A3D5-838C-C781B4ED5A5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95B23720-8602-F63B-BBE2-31A6E04E05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BCCE86D-C989-CE7D-CB61-72C32D3102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6A689-F3CE-432A-A9BA-4A41827DEE15}" type="datetimeFigureOut">
              <a:rPr lang="fr-FR" smtClean="0"/>
              <a:t>15/06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BF8897E-8DEB-9A88-530F-DFA16C7510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AEA698C-664C-DFC6-159B-7109349702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09C14-0F56-452B-9D10-54A08F0492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767160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07C213B-77FA-F4F4-6DC1-CA6DBEDBB3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C449A51-60D9-354A-AAAA-57BFDFD63B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6AD75098-B1E0-8056-B608-A490B29B29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E766CF93-563C-C930-FC72-633976D0CA3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D5EDB91F-D851-D8E3-CF30-D33F1CAB793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6A5709FE-6E0E-5ED0-0B6E-82F3365E73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6A689-F3CE-432A-A9BA-4A41827DEE15}" type="datetimeFigureOut">
              <a:rPr lang="fr-FR" smtClean="0"/>
              <a:t>15/06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95BE59D7-EEBA-BBC8-2A48-D305E20890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D2D36451-4B58-F8AA-7736-C5B2D70C2E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09C14-0F56-452B-9D10-54A08F0492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09983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CCF4855-9C7A-E0B8-6D85-5D58D0E1ED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7F6AAF24-2521-FE57-2687-6DEA331472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6A689-F3CE-432A-A9BA-4A41827DEE15}" type="datetimeFigureOut">
              <a:rPr lang="fr-FR" smtClean="0"/>
              <a:t>15/06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6CAD836F-3618-41DC-47AD-664C0543A6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7ACA8497-24D8-D315-AC4D-43FA516D89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09C14-0F56-452B-9D10-54A08F0492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59030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F49999C7-9111-1ADE-27D8-02F16E042E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6A689-F3CE-432A-A9BA-4A41827DEE15}" type="datetimeFigureOut">
              <a:rPr lang="fr-FR" smtClean="0"/>
              <a:t>15/06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F66EF524-99FA-E5E1-94C7-CC5D7E0AAE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556C2E1A-BF8F-43CA-3BCE-038866E8C0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09C14-0F56-452B-9D10-54A08F0492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393790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3A34409-243B-CE51-D339-408A24A0B9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5FF3B80-446D-D99B-A5DB-93AE19FFA4A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27F5984-5B8A-B102-EC51-DF1650C6AE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CC756AC-4A09-E9FD-7590-0A39988EBB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6A689-F3CE-432A-A9BA-4A41827DEE15}" type="datetimeFigureOut">
              <a:rPr lang="fr-FR" smtClean="0"/>
              <a:t>15/06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BFAE311-ABD7-AE2A-4431-895BA005F2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EDE117E-2618-4B5B-567B-35BCCF61D6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09C14-0F56-452B-9D10-54A08F0492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130434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2F878D2-3A73-7BA2-F0CA-8E37A7B85F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BCAB5368-C82B-FAC6-7FF4-B2E0FF43826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8BB8D90-1854-6389-3CB8-5A6F6FE527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608A81E8-5CFA-F6D2-ADFD-C2792C838B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6A689-F3CE-432A-A9BA-4A41827DEE15}" type="datetimeFigureOut">
              <a:rPr lang="fr-FR" smtClean="0"/>
              <a:t>15/06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2B289B98-262E-9A3B-E47B-04199CDEB4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1758484-5DED-F18E-B1CE-2451A46584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09C14-0F56-452B-9D10-54A08F0492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338287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B73AA84C-5E15-A0C3-0E87-AB0BAB60B8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6C8BF3AD-F06E-64C8-B331-8D9E1BDF4C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DA95079-91B4-A208-C4BD-F97D64E6C8E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B6A689-F3CE-432A-A9BA-4A41827DEE15}" type="datetimeFigureOut">
              <a:rPr lang="fr-FR" smtClean="0"/>
              <a:t>15/06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AF2A3A6-C92F-B1E8-A4EB-3D4781C1319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61227FC-7A22-D644-DABA-AE7106AE178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909C14-0F56-452B-9D10-54A08F0492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65925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7.bin"/><Relationship Id="rId3" Type="http://schemas.openxmlformats.org/officeDocument/2006/relationships/image" Target="../media/image4.emf"/><Relationship Id="rId7" Type="http://schemas.openxmlformats.org/officeDocument/2006/relationships/image" Target="../media/image6.e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6.bin"/><Relationship Id="rId5" Type="http://schemas.openxmlformats.org/officeDocument/2006/relationships/image" Target="../media/image5.emf"/><Relationship Id="rId4" Type="http://schemas.openxmlformats.org/officeDocument/2006/relationships/oleObject" Target="../embeddings/oleObject5.bin"/><Relationship Id="rId9" Type="http://schemas.openxmlformats.org/officeDocument/2006/relationships/image" Target="../media/image7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1.bin"/><Relationship Id="rId3" Type="http://schemas.openxmlformats.org/officeDocument/2006/relationships/image" Target="../media/image8.emf"/><Relationship Id="rId7" Type="http://schemas.openxmlformats.org/officeDocument/2006/relationships/image" Target="../media/image10.emf"/><Relationship Id="rId2" Type="http://schemas.openxmlformats.org/officeDocument/2006/relationships/oleObject" Target="../embeddings/oleObject8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0.bin"/><Relationship Id="rId5" Type="http://schemas.openxmlformats.org/officeDocument/2006/relationships/image" Target="../media/image9.emf"/><Relationship Id="rId4" Type="http://schemas.openxmlformats.org/officeDocument/2006/relationships/oleObject" Target="../embeddings/oleObject9.bin"/><Relationship Id="rId9" Type="http://schemas.openxmlformats.org/officeDocument/2006/relationships/image" Target="../media/image11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oleObject" Target="../embeddings/oleObject12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3.emf"/><Relationship Id="rId4" Type="http://schemas.openxmlformats.org/officeDocument/2006/relationships/oleObject" Target="../embeddings/oleObject13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7.bin"/><Relationship Id="rId3" Type="http://schemas.openxmlformats.org/officeDocument/2006/relationships/image" Target="../media/image14.emf"/><Relationship Id="rId7" Type="http://schemas.openxmlformats.org/officeDocument/2006/relationships/image" Target="../media/image16.emf"/><Relationship Id="rId2" Type="http://schemas.openxmlformats.org/officeDocument/2006/relationships/oleObject" Target="../embeddings/oleObject14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6.bin"/><Relationship Id="rId11" Type="http://schemas.openxmlformats.org/officeDocument/2006/relationships/image" Target="../media/image18.emf"/><Relationship Id="rId5" Type="http://schemas.openxmlformats.org/officeDocument/2006/relationships/image" Target="../media/image15.emf"/><Relationship Id="rId10" Type="http://schemas.openxmlformats.org/officeDocument/2006/relationships/oleObject" Target="../embeddings/oleObject18.bin"/><Relationship Id="rId4" Type="http://schemas.openxmlformats.org/officeDocument/2006/relationships/oleObject" Target="../embeddings/oleObject15.bin"/><Relationship Id="rId9" Type="http://schemas.openxmlformats.org/officeDocument/2006/relationships/image" Target="../media/image17.em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B137F57-31E7-B73C-0518-57F1278581EC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fr-FR" dirty="0" err="1"/>
              <a:t>Supplementary</a:t>
            </a:r>
            <a:r>
              <a:rPr lang="fr-FR" dirty="0"/>
              <a:t> </a:t>
            </a:r>
            <a:r>
              <a:rPr lang="fr-FR" dirty="0" err="1"/>
              <a:t>materials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9315267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t 3">
            <a:extLst>
              <a:ext uri="{FF2B5EF4-FFF2-40B4-BE49-F238E27FC236}">
                <a16:creationId xmlns:a16="http://schemas.microsoft.com/office/drawing/2014/main" id="{0D851CF8-52E0-F4AB-BF81-0E4D5A55318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791643" y="517525"/>
          <a:ext cx="4017962" cy="2911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4018754" imgH="2911341" progId="Prism8.Document">
                  <p:embed/>
                </p:oleObj>
              </mc:Choice>
              <mc:Fallback>
                <p:oleObj name="Prism 8" r:id="rId2" imgW="4018754" imgH="2911341" progId="Prism8.Document">
                  <p:embed/>
                  <p:pic>
                    <p:nvPicPr>
                      <p:cNvPr id="4" name="Objet 3">
                        <a:extLst>
                          <a:ext uri="{FF2B5EF4-FFF2-40B4-BE49-F238E27FC236}">
                            <a16:creationId xmlns:a16="http://schemas.microsoft.com/office/drawing/2014/main" id="{0D851CF8-52E0-F4AB-BF81-0E4D5A55318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791643" y="517525"/>
                        <a:ext cx="4017962" cy="2911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t 4">
            <a:extLst>
              <a:ext uri="{FF2B5EF4-FFF2-40B4-BE49-F238E27FC236}">
                <a16:creationId xmlns:a16="http://schemas.microsoft.com/office/drawing/2014/main" id="{B69C34D7-EA32-6CBA-8636-4BE56668CBA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791642" y="2753432"/>
          <a:ext cx="4017963" cy="2911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4018754" imgH="2911341" progId="Prism8.Document">
                  <p:embed/>
                </p:oleObj>
              </mc:Choice>
              <mc:Fallback>
                <p:oleObj name="Prism 8" r:id="rId4" imgW="4018754" imgH="2911341" progId="Prism8.Document">
                  <p:embed/>
                  <p:pic>
                    <p:nvPicPr>
                      <p:cNvPr id="5" name="Objet 4">
                        <a:extLst>
                          <a:ext uri="{FF2B5EF4-FFF2-40B4-BE49-F238E27FC236}">
                            <a16:creationId xmlns:a16="http://schemas.microsoft.com/office/drawing/2014/main" id="{B69C34D7-EA32-6CBA-8636-4BE56668CBA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791642" y="2753432"/>
                        <a:ext cx="4017963" cy="2911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ZoneTexte 5">
            <a:extLst>
              <a:ext uri="{FF2B5EF4-FFF2-40B4-BE49-F238E27FC236}">
                <a16:creationId xmlns:a16="http://schemas.microsoft.com/office/drawing/2014/main" id="{75982ED5-4401-8291-20A6-0B1C1D01DCD3}"/>
              </a:ext>
            </a:extLst>
          </p:cNvPr>
          <p:cNvSpPr txBox="1"/>
          <p:nvPr/>
        </p:nvSpPr>
        <p:spPr>
          <a:xfrm>
            <a:off x="330553" y="5401392"/>
            <a:ext cx="11311822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100" b="1" dirty="0">
                <a:latin typeface="Palatino Linotype" panose="02040502050505030304" pitchFamily="18" charset="0"/>
              </a:rPr>
              <a:t>Figure S1. </a:t>
            </a:r>
            <a:r>
              <a:rPr lang="en-US" sz="1100" b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R-204-5p overexpression </a:t>
            </a:r>
            <a:r>
              <a:rPr lang="en-US" sz="1100" b="1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oes not i</a:t>
            </a:r>
            <a:r>
              <a:rPr lang="en-US" sz="1100" b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pact the growth </a:t>
            </a:r>
            <a:r>
              <a:rPr lang="en-US" sz="1100" b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TPC-1 and BCPAP cells</a:t>
            </a:r>
          </a:p>
          <a:p>
            <a:pPr algn="just"/>
            <a:r>
              <a:rPr lang="en-US" sz="110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) m</a:t>
            </a:r>
            <a:r>
              <a:rPr lang="en-US" sz="1100" b="0" i="0" dirty="0">
                <a:effectLst/>
                <a:latin typeface="Palatino Linotype" panose="02040502050505030304" pitchFamily="18" charset="0"/>
              </a:rPr>
              <a:t>iR-204-5p expression levels were</a:t>
            </a:r>
            <a:r>
              <a:rPr lang="en-US" sz="1100" dirty="0">
                <a:latin typeface="Palatino Linotype" panose="02040502050505030304" pitchFamily="18" charset="0"/>
              </a:rPr>
              <a:t> analyzed by RT-qPCR in TPC-1 and BCPAP cells on days 1, 2, 3, 4 and 7 following miR-204-5p mimic (miR-204-5p) and mimic negative control (miR-NC) transfection (n=3). </a:t>
            </a:r>
            <a:r>
              <a:rPr lang="en-US" sz="1100" b="0" i="0" dirty="0">
                <a:effectLst/>
                <a:latin typeface="Palatino Linotype" panose="02040502050505030304" pitchFamily="18" charset="0"/>
              </a:rPr>
              <a:t>***P&lt;0.001 vs miR-NC. (b) </a:t>
            </a:r>
            <a:r>
              <a:rPr lang="en-US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R-204-5p overexpression has no impact on the growth of TPC-1 and BCPAP 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lls. </a:t>
            </a:r>
            <a:r>
              <a:rPr lang="en-US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b="0" i="0" dirty="0">
                <a:effectLst/>
                <a:latin typeface="Palatino Linotype" panose="02040502050505030304" pitchFamily="18" charset="0"/>
              </a:rPr>
              <a:t>The number of cells </a:t>
            </a:r>
            <a:r>
              <a:rPr lang="en-US" sz="1100" dirty="0">
                <a:latin typeface="Palatino Linotype" panose="02040502050505030304" pitchFamily="18" charset="0"/>
              </a:rPr>
              <a:t>was analyzed by counting cells on days 1, 2, 3, 4 following mimic miR-204-5p (miR-204-5p) and mimic negative control (miR-NC) transfection (n=3). </a:t>
            </a:r>
            <a:endParaRPr lang="en-US" sz="1100" b="0" i="0" dirty="0">
              <a:effectLst/>
              <a:latin typeface="Palatino Linotype" panose="02040502050505030304" pitchFamily="18" charset="0"/>
            </a:endParaRPr>
          </a:p>
          <a:p>
            <a:pPr algn="just"/>
            <a:endParaRPr lang="en-US" sz="1100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7" name="Objet 6">
            <a:extLst>
              <a:ext uri="{FF2B5EF4-FFF2-40B4-BE49-F238E27FC236}">
                <a16:creationId xmlns:a16="http://schemas.microsoft.com/office/drawing/2014/main" id="{BBCAE0C3-3919-6DF0-966C-E0D418446C2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28664" y="1313609"/>
          <a:ext cx="4065887" cy="27166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4640709" imgH="3100366" progId="Prism8.Document">
                  <p:embed/>
                </p:oleObj>
              </mc:Choice>
              <mc:Fallback>
                <p:oleObj name="Prism 8" r:id="rId6" imgW="4640709" imgH="3100366" progId="Prism8.Document">
                  <p:embed/>
                  <p:pic>
                    <p:nvPicPr>
                      <p:cNvPr id="7" name="Objet 6">
                        <a:extLst>
                          <a:ext uri="{FF2B5EF4-FFF2-40B4-BE49-F238E27FC236}">
                            <a16:creationId xmlns:a16="http://schemas.microsoft.com/office/drawing/2014/main" id="{BBCAE0C3-3919-6DF0-966C-E0D418446C2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728664" y="1313609"/>
                        <a:ext cx="4065887" cy="27166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ZoneTexte 2">
            <a:extLst>
              <a:ext uri="{FF2B5EF4-FFF2-40B4-BE49-F238E27FC236}">
                <a16:creationId xmlns:a16="http://schemas.microsoft.com/office/drawing/2014/main" id="{80477A47-C5D0-6822-C427-808D1D6F89E7}"/>
              </a:ext>
            </a:extLst>
          </p:cNvPr>
          <p:cNvSpPr txBox="1"/>
          <p:nvPr/>
        </p:nvSpPr>
        <p:spPr>
          <a:xfrm flipH="1">
            <a:off x="330553" y="690378"/>
            <a:ext cx="219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a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8AE41647-E4FB-4009-C23A-F698EC168066}"/>
              </a:ext>
            </a:extLst>
          </p:cNvPr>
          <p:cNvSpPr txBox="1"/>
          <p:nvPr/>
        </p:nvSpPr>
        <p:spPr>
          <a:xfrm flipH="1">
            <a:off x="6096000" y="713768"/>
            <a:ext cx="219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7970784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Zone de texte 2">
            <a:extLst>
              <a:ext uri="{FF2B5EF4-FFF2-40B4-BE49-F238E27FC236}">
                <a16:creationId xmlns:a16="http://schemas.microsoft.com/office/drawing/2014/main" id="{111A5ACE-1CE5-009C-BCE7-BE7505922E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89455" y="1117917"/>
            <a:ext cx="2360930" cy="41910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fr-FR" sz="11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PC-1</a:t>
            </a:r>
          </a:p>
        </p:txBody>
      </p:sp>
      <p:sp>
        <p:nvSpPr>
          <p:cNvPr id="19" name="Zone de texte 2">
            <a:extLst>
              <a:ext uri="{FF2B5EF4-FFF2-40B4-BE49-F238E27FC236}">
                <a16:creationId xmlns:a16="http://schemas.microsoft.com/office/drawing/2014/main" id="{E30D48D1-93D5-5908-F3BE-F86EED48D015}"/>
              </a:ext>
            </a:extLst>
          </p:cNvPr>
          <p:cNvSpPr txBox="1"/>
          <p:nvPr/>
        </p:nvSpPr>
        <p:spPr>
          <a:xfrm>
            <a:off x="7770495" y="1063942"/>
            <a:ext cx="2360930" cy="430530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fr-FR" sz="11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CPAP</a:t>
            </a:r>
          </a:p>
        </p:txBody>
      </p:sp>
      <p:graphicFrame>
        <p:nvGraphicFramePr>
          <p:cNvPr id="20" name="Objet 19">
            <a:extLst>
              <a:ext uri="{FF2B5EF4-FFF2-40B4-BE49-F238E27FC236}">
                <a16:creationId xmlns:a16="http://schemas.microsoft.com/office/drawing/2014/main" id="{D7638B16-4FF2-33A1-BF01-153E19379A2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23605533"/>
              </p:ext>
            </p:extLst>
          </p:nvPr>
        </p:nvGraphicFramePr>
        <p:xfrm>
          <a:off x="1305241" y="1537017"/>
          <a:ext cx="3703637" cy="28934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4377089" imgH="3421888" progId="Prism8.Document">
                  <p:embed/>
                </p:oleObj>
              </mc:Choice>
              <mc:Fallback>
                <p:oleObj name="Prism 8" r:id="rId2" imgW="4377089" imgH="3421888" progId="Prism8.Document">
                  <p:embed/>
                  <p:pic>
                    <p:nvPicPr>
                      <p:cNvPr id="20" name="Objet 19">
                        <a:extLst>
                          <a:ext uri="{FF2B5EF4-FFF2-40B4-BE49-F238E27FC236}">
                            <a16:creationId xmlns:a16="http://schemas.microsoft.com/office/drawing/2014/main" id="{D7638B16-4FF2-33A1-BF01-153E19379A21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305241" y="1537017"/>
                        <a:ext cx="3703637" cy="2893466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t 20">
            <a:extLst>
              <a:ext uri="{FF2B5EF4-FFF2-40B4-BE49-F238E27FC236}">
                <a16:creationId xmlns:a16="http://schemas.microsoft.com/office/drawing/2014/main" id="{FAD449DD-0A22-1953-33B9-761C8670A43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90551443"/>
              </p:ext>
            </p:extLst>
          </p:nvPr>
        </p:nvGraphicFramePr>
        <p:xfrm>
          <a:off x="7352118" y="1645112"/>
          <a:ext cx="3478530" cy="26772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4419585" imgH="3418648" progId="Prism8.Document">
                  <p:embed/>
                </p:oleObj>
              </mc:Choice>
              <mc:Fallback>
                <p:oleObj name="Prism 8" r:id="rId4" imgW="4419585" imgH="3418648" progId="Prism8.Document">
                  <p:embed/>
                  <p:pic>
                    <p:nvPicPr>
                      <p:cNvPr id="21" name="Objet 20">
                        <a:extLst>
                          <a:ext uri="{FF2B5EF4-FFF2-40B4-BE49-F238E27FC236}">
                            <a16:creationId xmlns:a16="http://schemas.microsoft.com/office/drawing/2014/main" id="{FAD449DD-0A22-1953-33B9-761C8670A43D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352118" y="1645112"/>
                        <a:ext cx="3478530" cy="2677276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t 21">
            <a:extLst>
              <a:ext uri="{FF2B5EF4-FFF2-40B4-BE49-F238E27FC236}">
                <a16:creationId xmlns:a16="http://schemas.microsoft.com/office/drawing/2014/main" id="{5204FBCA-C6C0-F6C6-666E-0CE738C0A71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64451702"/>
              </p:ext>
            </p:extLst>
          </p:nvPr>
        </p:nvGraphicFramePr>
        <p:xfrm>
          <a:off x="1388267" y="4071619"/>
          <a:ext cx="3537584" cy="2839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4280933" imgH="3437010" progId="Prism8.Document">
                  <p:embed/>
                </p:oleObj>
              </mc:Choice>
              <mc:Fallback>
                <p:oleObj name="Prism 8" r:id="rId6" imgW="4280933" imgH="3437010" progId="Prism8.Document">
                  <p:embed/>
                  <p:pic>
                    <p:nvPicPr>
                      <p:cNvPr id="22" name="Objet 21">
                        <a:extLst>
                          <a:ext uri="{FF2B5EF4-FFF2-40B4-BE49-F238E27FC236}">
                            <a16:creationId xmlns:a16="http://schemas.microsoft.com/office/drawing/2014/main" id="{5204FBCA-C6C0-F6C6-666E-0CE738C0A714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388267" y="4071619"/>
                        <a:ext cx="3537584" cy="2839900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t 22">
            <a:extLst>
              <a:ext uri="{FF2B5EF4-FFF2-40B4-BE49-F238E27FC236}">
                <a16:creationId xmlns:a16="http://schemas.microsoft.com/office/drawing/2014/main" id="{3F154F0B-1D99-44EC-DED2-229F4A6DC88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39526651"/>
              </p:ext>
            </p:extLst>
          </p:nvPr>
        </p:nvGraphicFramePr>
        <p:xfrm>
          <a:off x="7435145" y="4071619"/>
          <a:ext cx="3373190" cy="28398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4302181" imgH="3624595" progId="Prism8.Document">
                  <p:embed/>
                </p:oleObj>
              </mc:Choice>
              <mc:Fallback>
                <p:oleObj name="Prism 8" r:id="rId8" imgW="4302181" imgH="3624595" progId="Prism8.Document">
                  <p:embed/>
                  <p:pic>
                    <p:nvPicPr>
                      <p:cNvPr id="23" name="Objet 22">
                        <a:extLst>
                          <a:ext uri="{FF2B5EF4-FFF2-40B4-BE49-F238E27FC236}">
                            <a16:creationId xmlns:a16="http://schemas.microsoft.com/office/drawing/2014/main" id="{3F154F0B-1D99-44EC-DED2-229F4A6DC88B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435145" y="4071619"/>
                        <a:ext cx="3373190" cy="2839899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ZoneTexte 3">
            <a:extLst>
              <a:ext uri="{FF2B5EF4-FFF2-40B4-BE49-F238E27FC236}">
                <a16:creationId xmlns:a16="http://schemas.microsoft.com/office/drawing/2014/main" id="{7D270F04-C3A4-CB67-582A-3E23B2226FB1}"/>
              </a:ext>
            </a:extLst>
          </p:cNvPr>
          <p:cNvSpPr txBox="1"/>
          <p:nvPr/>
        </p:nvSpPr>
        <p:spPr>
          <a:xfrm>
            <a:off x="594200" y="229408"/>
            <a:ext cx="11003599" cy="68389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100" b="1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.  The MAPK signalling pathway regulates EMT-related genes in TPC-1 and BCPAP cells. </a:t>
            </a:r>
            <a:r>
              <a:rPr lang="en-US" sz="1100" kern="1200" dirty="0">
                <a:solidFill>
                  <a:srgbClr val="222222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" panose="02020603050405020304" pitchFamily="18" charset="0"/>
              </a:rPr>
              <a:t>SOX4, SNAI1, SNAI2, ZEB1 and CDH1 mRNA expression was analyzed by RT-qPCR in TPC-1 and BCPAP cells treated with different inhibitors during 24h : trametinib (MEKi), GDC0941 (PI3Ki), dabrafenib (BRAFi), trametinib and dabrafenib (MEKi+ BRAFi) and  BMS-754807 (IGF1Ri). (NT: not treated cells). DSMO treatment was used as negative control. 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P&lt;0,05; **P&lt;0.01 and ***P&lt;0.001 vs. DMSO.</a:t>
            </a:r>
            <a:r>
              <a:rPr lang="en-US" sz="1100" kern="1200" dirty="0">
                <a:solidFill>
                  <a:srgbClr val="222222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" panose="02020603050405020304" pitchFamily="18" charset="0"/>
              </a:rPr>
              <a:t> 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fr-FR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30970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t 3">
            <a:extLst>
              <a:ext uri="{FF2B5EF4-FFF2-40B4-BE49-F238E27FC236}">
                <a16:creationId xmlns:a16="http://schemas.microsoft.com/office/drawing/2014/main" id="{5940388E-FE61-AC0F-4C35-36C06268033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9016969"/>
              </p:ext>
            </p:extLst>
          </p:nvPr>
        </p:nvGraphicFramePr>
        <p:xfrm>
          <a:off x="1100455" y="737870"/>
          <a:ext cx="3827145" cy="30984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4431830" imgH="3595431" progId="Prism8.Document">
                  <p:embed/>
                </p:oleObj>
              </mc:Choice>
              <mc:Fallback>
                <p:oleObj name="Prism 8" r:id="rId2" imgW="4431830" imgH="3595431" progId="Prism8.Document">
                  <p:embed/>
                  <p:pic>
                    <p:nvPicPr>
                      <p:cNvPr id="4" name="Objet 3">
                        <a:extLst>
                          <a:ext uri="{FF2B5EF4-FFF2-40B4-BE49-F238E27FC236}">
                            <a16:creationId xmlns:a16="http://schemas.microsoft.com/office/drawing/2014/main" id="{5940388E-FE61-AC0F-4C35-36C062680339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00455" y="737870"/>
                        <a:ext cx="3827145" cy="3098492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t 4">
            <a:extLst>
              <a:ext uri="{FF2B5EF4-FFF2-40B4-BE49-F238E27FC236}">
                <a16:creationId xmlns:a16="http://schemas.microsoft.com/office/drawing/2014/main" id="{ABCA7FD6-B441-FE8A-1745-AA468F00072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39935470"/>
              </p:ext>
            </p:extLst>
          </p:nvPr>
        </p:nvGraphicFramePr>
        <p:xfrm>
          <a:off x="7135815" y="696764"/>
          <a:ext cx="3827144" cy="31807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4352600" imgH="3626035" progId="Prism8.Document">
                  <p:embed/>
                </p:oleObj>
              </mc:Choice>
              <mc:Fallback>
                <p:oleObj name="Prism 8" r:id="rId4" imgW="4352600" imgH="3626035" progId="Prism8.Document">
                  <p:embed/>
                  <p:pic>
                    <p:nvPicPr>
                      <p:cNvPr id="5" name="Objet 4">
                        <a:extLst>
                          <a:ext uri="{FF2B5EF4-FFF2-40B4-BE49-F238E27FC236}">
                            <a16:creationId xmlns:a16="http://schemas.microsoft.com/office/drawing/2014/main" id="{ABCA7FD6-B441-FE8A-1745-AA468F000725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135815" y="696764"/>
                        <a:ext cx="3827144" cy="3180703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t 5">
            <a:extLst>
              <a:ext uri="{FF2B5EF4-FFF2-40B4-BE49-F238E27FC236}">
                <a16:creationId xmlns:a16="http://schemas.microsoft.com/office/drawing/2014/main" id="{5071C5C2-A4F5-0415-DEF0-DE8BB07B9E9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94825610"/>
              </p:ext>
            </p:extLst>
          </p:nvPr>
        </p:nvGraphicFramePr>
        <p:xfrm>
          <a:off x="1164747" y="3579495"/>
          <a:ext cx="3698559" cy="28383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4473246" imgH="3440250" progId="Prism8.Document">
                  <p:embed/>
                </p:oleObj>
              </mc:Choice>
              <mc:Fallback>
                <p:oleObj name="Prism 8" r:id="rId6" imgW="4473246" imgH="3440250" progId="Prism8.Document">
                  <p:embed/>
                  <p:pic>
                    <p:nvPicPr>
                      <p:cNvPr id="6" name="Objet 5">
                        <a:extLst>
                          <a:ext uri="{FF2B5EF4-FFF2-40B4-BE49-F238E27FC236}">
                            <a16:creationId xmlns:a16="http://schemas.microsoft.com/office/drawing/2014/main" id="{5071C5C2-A4F5-0415-DEF0-DE8BB07B9E9B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64747" y="3579495"/>
                        <a:ext cx="3698559" cy="2838388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t 6">
            <a:extLst>
              <a:ext uri="{FF2B5EF4-FFF2-40B4-BE49-F238E27FC236}">
                <a16:creationId xmlns:a16="http://schemas.microsoft.com/office/drawing/2014/main" id="{388AFA03-16D3-F271-3A77-360AE3F162C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37540496"/>
              </p:ext>
            </p:extLst>
          </p:nvPr>
        </p:nvGraphicFramePr>
        <p:xfrm>
          <a:off x="7176455" y="3667533"/>
          <a:ext cx="3600291" cy="2750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4457760" imgH="3411087" progId="Prism8.Document">
                  <p:embed/>
                </p:oleObj>
              </mc:Choice>
              <mc:Fallback>
                <p:oleObj name="Prism 8" r:id="rId8" imgW="4457760" imgH="3411087" progId="Prism8.Document">
                  <p:embed/>
                  <p:pic>
                    <p:nvPicPr>
                      <p:cNvPr id="7" name="Objet 6">
                        <a:extLst>
                          <a:ext uri="{FF2B5EF4-FFF2-40B4-BE49-F238E27FC236}">
                            <a16:creationId xmlns:a16="http://schemas.microsoft.com/office/drawing/2014/main" id="{388AFA03-16D3-F271-3A77-360AE3F162C3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176455" y="3667533"/>
                        <a:ext cx="3600291" cy="2750350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8925407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t 3">
            <a:extLst>
              <a:ext uri="{FF2B5EF4-FFF2-40B4-BE49-F238E27FC236}">
                <a16:creationId xmlns:a16="http://schemas.microsoft.com/office/drawing/2014/main" id="{29BE5AD6-295C-1F6B-F3FC-FDD26F7E894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37796839"/>
              </p:ext>
            </p:extLst>
          </p:nvPr>
        </p:nvGraphicFramePr>
        <p:xfrm>
          <a:off x="1016000" y="1143169"/>
          <a:ext cx="3895090" cy="29907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4465323" imgH="3421888" progId="Prism8.Document">
                  <p:embed/>
                </p:oleObj>
              </mc:Choice>
              <mc:Fallback>
                <p:oleObj name="Prism 8" r:id="rId2" imgW="4465323" imgH="3421888" progId="Prism8.Document">
                  <p:embed/>
                  <p:pic>
                    <p:nvPicPr>
                      <p:cNvPr id="4" name="Objet 3">
                        <a:extLst>
                          <a:ext uri="{FF2B5EF4-FFF2-40B4-BE49-F238E27FC236}">
                            <a16:creationId xmlns:a16="http://schemas.microsoft.com/office/drawing/2014/main" id="{29BE5AD6-295C-1F6B-F3FC-FDD26F7E8940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16000" y="1143169"/>
                        <a:ext cx="3895090" cy="2990722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t 4">
            <a:extLst>
              <a:ext uri="{FF2B5EF4-FFF2-40B4-BE49-F238E27FC236}">
                <a16:creationId xmlns:a16="http://schemas.microsoft.com/office/drawing/2014/main" id="{E4EB6957-04CC-7DD6-1373-9CDD361EE42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34934532"/>
              </p:ext>
            </p:extLst>
          </p:nvPr>
        </p:nvGraphicFramePr>
        <p:xfrm>
          <a:off x="7380923" y="1203643"/>
          <a:ext cx="3795077" cy="29302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4419585" imgH="3418648" progId="Prism8.Document">
                  <p:embed/>
                </p:oleObj>
              </mc:Choice>
              <mc:Fallback>
                <p:oleObj name="Prism 8" r:id="rId4" imgW="4419585" imgH="3418648" progId="Prism8.Document">
                  <p:embed/>
                  <p:pic>
                    <p:nvPicPr>
                      <p:cNvPr id="5" name="Objet 4">
                        <a:extLst>
                          <a:ext uri="{FF2B5EF4-FFF2-40B4-BE49-F238E27FC236}">
                            <a16:creationId xmlns:a16="http://schemas.microsoft.com/office/drawing/2014/main" id="{E4EB6957-04CC-7DD6-1373-9CDD361EE420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380923" y="1203643"/>
                        <a:ext cx="3795077" cy="2930248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33535146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76DA2073-1434-AA48-46D3-A87753ED1BDC}"/>
              </a:ext>
            </a:extLst>
          </p:cNvPr>
          <p:cNvSpPr txBox="1"/>
          <p:nvPr/>
        </p:nvSpPr>
        <p:spPr>
          <a:xfrm>
            <a:off x="436460" y="102176"/>
            <a:ext cx="11700954" cy="17191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100" b="1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3. HMGA2 knockdown does not impact proliferation or apoptosis, while MAPK signalling pathway inhibition reduces proliferation in TPC-1 and BCPAP cells</a:t>
            </a:r>
            <a:r>
              <a:rPr lang="en-GB" sz="1100" b="1" dirty="0">
                <a:solidFill>
                  <a:srgbClr val="000000"/>
                </a:solidFill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GB" sz="1100" b="1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Cells were counted </a:t>
            </a:r>
            <a:r>
              <a:rPr lang="en-US" sz="1100" dirty="0">
                <a:latin typeface="Palatino Linotype" panose="02040502050505030304" pitchFamily="18" charset="0"/>
              </a:rPr>
              <a:t>on days 1, 2, 3, 4 following transfection with a siRNA against HMGA2 (siRNA HMGA2) and a control siRNA (siRNA NC) (b)</a:t>
            </a:r>
            <a:r>
              <a:rPr lang="fr-FR" sz="1100" dirty="0">
                <a:latin typeface="Palatino Linotype" panose="02040502050505030304" pitchFamily="18" charset="0"/>
              </a:rPr>
              <a:t> EdU incorporation </a:t>
            </a:r>
            <a:r>
              <a:rPr lang="fr-FR" sz="1100" dirty="0" err="1">
                <a:latin typeface="Palatino Linotype" panose="02040502050505030304" pitchFamily="18" charset="0"/>
              </a:rPr>
              <a:t>was</a:t>
            </a:r>
            <a:r>
              <a:rPr lang="fr-FR" sz="1100" dirty="0">
                <a:latin typeface="Palatino Linotype" panose="02040502050505030304" pitchFamily="18" charset="0"/>
              </a:rPr>
              <a:t> </a:t>
            </a:r>
            <a:r>
              <a:rPr lang="fr-FR" sz="1100" dirty="0" err="1">
                <a:latin typeface="Palatino Linotype" panose="02040502050505030304" pitchFamily="18" charset="0"/>
              </a:rPr>
              <a:t>analyzed</a:t>
            </a:r>
            <a:r>
              <a:rPr lang="fr-FR" sz="1100" dirty="0">
                <a:latin typeface="Palatino Linotype" panose="02040502050505030304" pitchFamily="18" charset="0"/>
              </a:rPr>
              <a:t> in TPC-1 and BCPAP </a:t>
            </a:r>
            <a:r>
              <a:rPr lang="fr-FR" sz="1100" dirty="0" err="1">
                <a:latin typeface="Palatino Linotype" panose="02040502050505030304" pitchFamily="18" charset="0"/>
              </a:rPr>
              <a:t>cells</a:t>
            </a:r>
            <a:r>
              <a:rPr lang="fr-FR" sz="1100" dirty="0">
                <a:latin typeface="Palatino Linotype" panose="02040502050505030304" pitchFamily="18" charset="0"/>
              </a:rPr>
              <a:t> by flow </a:t>
            </a:r>
            <a:r>
              <a:rPr lang="fr-FR" sz="1100" dirty="0" err="1">
                <a:latin typeface="Palatino Linotype" panose="02040502050505030304" pitchFamily="18" charset="0"/>
              </a:rPr>
              <a:t>cytometry</a:t>
            </a:r>
            <a:r>
              <a:rPr lang="fr-FR" sz="1100" dirty="0">
                <a:latin typeface="Palatino Linotype" panose="02040502050505030304" pitchFamily="18" charset="0"/>
              </a:rPr>
              <a:t> 3 </a:t>
            </a:r>
            <a:r>
              <a:rPr lang="fr-FR" sz="1100" dirty="0" err="1">
                <a:latin typeface="Palatino Linotype" panose="02040502050505030304" pitchFamily="18" charset="0"/>
              </a:rPr>
              <a:t>days</a:t>
            </a:r>
            <a:r>
              <a:rPr lang="fr-FR" sz="1100" dirty="0">
                <a:latin typeface="Palatino Linotype" panose="02040502050505030304" pitchFamily="18" charset="0"/>
              </a:rPr>
              <a:t> </a:t>
            </a:r>
            <a:r>
              <a:rPr lang="fr-FR" sz="1100" dirty="0" err="1">
                <a:latin typeface="Palatino Linotype" panose="02040502050505030304" pitchFamily="18" charset="0"/>
              </a:rPr>
              <a:t>after</a:t>
            </a:r>
            <a:r>
              <a:rPr lang="fr-FR" sz="1100" dirty="0">
                <a:latin typeface="Palatino Linotype" panose="02040502050505030304" pitchFamily="18" charset="0"/>
              </a:rPr>
              <a:t> transfection </a:t>
            </a:r>
            <a:r>
              <a:rPr lang="en-US" sz="1100" dirty="0">
                <a:latin typeface="Palatino Linotype" panose="02040502050505030304" pitchFamily="18" charset="0"/>
              </a:rPr>
              <a:t>in non transfected cells (NT) and in cells transfected with a siRNA against HMGA2 (siRNA HMGA2) and a control siRNA (siRNA NC) and in non transfected cells treated with trametinib (MEKi) for 24h. DMSO was used as negative control (n=3).</a:t>
            </a:r>
            <a:r>
              <a:rPr lang="fr-FR" sz="1100" b="0" i="0" dirty="0">
                <a:effectLst/>
                <a:latin typeface="Palatino Linotype" panose="02040502050505030304" pitchFamily="18" charset="0"/>
              </a:rPr>
              <a:t> *P&lt;0.05 vs. </a:t>
            </a:r>
            <a:r>
              <a:rPr lang="fr-FR" sz="1100" dirty="0">
                <a:latin typeface="Palatino Linotype" panose="02040502050505030304" pitchFamily="18" charset="0"/>
              </a:rPr>
              <a:t>DMSO. (</a:t>
            </a:r>
            <a:r>
              <a:rPr lang="en-US" sz="1100" dirty="0">
                <a:latin typeface="Palatino Linotype" panose="02040502050505030304" pitchFamily="18" charset="0"/>
              </a:rPr>
              <a:t>c) Cell apoptosis was analyzed by western blotting with cleaved CASPASE-3 and cleaved PARP antibodies and quantified by ImageJ in TPC-1 and BCPAP cells 3 days after transfection, in non transfected cells (NT), in cells transfected with a control siRNA (siRNA-NC) or a siRNA against HMGA2 (siRNA-HMGA2), and in non transfected cells treated with trametinib (MEKi) for 24h. TPC-1 and BCPAP cells treated with </a:t>
            </a:r>
            <a:r>
              <a:rPr lang="en-US" sz="1100" dirty="0" err="1">
                <a:latin typeface="Palatino Linotype" panose="02040502050505030304" pitchFamily="18" charset="0"/>
              </a:rPr>
              <a:t>staurosporine</a:t>
            </a:r>
            <a:r>
              <a:rPr lang="en-US" sz="1100" dirty="0">
                <a:latin typeface="Palatino Linotype" panose="02040502050505030304" pitchFamily="18" charset="0"/>
              </a:rPr>
              <a:t> for 20 hours were used as positive control (C+).</a:t>
            </a:r>
          </a:p>
        </p:txBody>
      </p:sp>
      <p:graphicFrame>
        <p:nvGraphicFramePr>
          <p:cNvPr id="5" name="Objet 4">
            <a:extLst>
              <a:ext uri="{FF2B5EF4-FFF2-40B4-BE49-F238E27FC236}">
                <a16:creationId xmlns:a16="http://schemas.microsoft.com/office/drawing/2014/main" id="{370A227B-4ED0-234E-D0F7-58FE0DED4CA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26090837"/>
              </p:ext>
            </p:extLst>
          </p:nvPr>
        </p:nvGraphicFramePr>
        <p:xfrm>
          <a:off x="429203" y="1504053"/>
          <a:ext cx="4016375" cy="2911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4015873" imgH="2911341" progId="Prism8.Document">
                  <p:embed/>
                </p:oleObj>
              </mc:Choice>
              <mc:Fallback>
                <p:oleObj name="Prism 8" r:id="rId2" imgW="4015873" imgH="2911341" progId="Prism8.Document">
                  <p:embed/>
                  <p:pic>
                    <p:nvPicPr>
                      <p:cNvPr id="5" name="Objet 4">
                        <a:extLst>
                          <a:ext uri="{FF2B5EF4-FFF2-40B4-BE49-F238E27FC236}">
                            <a16:creationId xmlns:a16="http://schemas.microsoft.com/office/drawing/2014/main" id="{370A227B-4ED0-234E-D0F7-58FE0DED4CA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29203" y="1504053"/>
                        <a:ext cx="4016375" cy="2911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t 5">
            <a:extLst>
              <a:ext uri="{FF2B5EF4-FFF2-40B4-BE49-F238E27FC236}">
                <a16:creationId xmlns:a16="http://schemas.microsoft.com/office/drawing/2014/main" id="{02D51C37-A77B-113B-C78A-E0D5C0D401C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53115705"/>
              </p:ext>
            </p:extLst>
          </p:nvPr>
        </p:nvGraphicFramePr>
        <p:xfrm>
          <a:off x="4891851" y="1504053"/>
          <a:ext cx="3938588" cy="2911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3938084" imgH="2911341" progId="Prism8.Document">
                  <p:embed/>
                </p:oleObj>
              </mc:Choice>
              <mc:Fallback>
                <p:oleObj name="Prism 8" r:id="rId4" imgW="3938084" imgH="2911341" progId="Prism8.Document">
                  <p:embed/>
                  <p:pic>
                    <p:nvPicPr>
                      <p:cNvPr id="6" name="Objet 5">
                        <a:extLst>
                          <a:ext uri="{FF2B5EF4-FFF2-40B4-BE49-F238E27FC236}">
                            <a16:creationId xmlns:a16="http://schemas.microsoft.com/office/drawing/2014/main" id="{02D51C37-A77B-113B-C78A-E0D5C0D401C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891851" y="1504053"/>
                        <a:ext cx="3938588" cy="2911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ZoneTexte 7">
            <a:extLst>
              <a:ext uri="{FF2B5EF4-FFF2-40B4-BE49-F238E27FC236}">
                <a16:creationId xmlns:a16="http://schemas.microsoft.com/office/drawing/2014/main" id="{2840C923-182C-703A-8261-41BE867308E0}"/>
              </a:ext>
            </a:extLst>
          </p:cNvPr>
          <p:cNvSpPr txBox="1"/>
          <p:nvPr/>
        </p:nvSpPr>
        <p:spPr>
          <a:xfrm flipH="1">
            <a:off x="319667" y="1310865"/>
            <a:ext cx="219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a</a:t>
            </a:r>
          </a:p>
        </p:txBody>
      </p:sp>
      <p:grpSp>
        <p:nvGrpSpPr>
          <p:cNvPr id="12" name="Groupe 11">
            <a:extLst>
              <a:ext uri="{FF2B5EF4-FFF2-40B4-BE49-F238E27FC236}">
                <a16:creationId xmlns:a16="http://schemas.microsoft.com/office/drawing/2014/main" id="{A03A7514-E83A-E2DA-B936-7474BBDCF89B}"/>
              </a:ext>
            </a:extLst>
          </p:cNvPr>
          <p:cNvGrpSpPr/>
          <p:nvPr/>
        </p:nvGrpSpPr>
        <p:grpSpPr>
          <a:xfrm>
            <a:off x="328738" y="3753304"/>
            <a:ext cx="4187642" cy="3118132"/>
            <a:chOff x="328738" y="3753304"/>
            <a:chExt cx="4187642" cy="3118132"/>
          </a:xfrm>
        </p:grpSpPr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EE5FDB1A-E7A7-3311-081E-10ECE0B4E9D5}"/>
                </a:ext>
              </a:extLst>
            </p:cNvPr>
            <p:cNvSpPr txBox="1"/>
            <p:nvPr/>
          </p:nvSpPr>
          <p:spPr>
            <a:xfrm flipH="1">
              <a:off x="328738" y="3753304"/>
              <a:ext cx="2190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b="1" dirty="0"/>
                <a:t>b</a:t>
              </a:r>
            </a:p>
          </p:txBody>
        </p:sp>
        <p:graphicFrame>
          <p:nvGraphicFramePr>
            <p:cNvPr id="11" name="Objet 10">
              <a:extLst>
                <a:ext uri="{FF2B5EF4-FFF2-40B4-BE49-F238E27FC236}">
                  <a16:creationId xmlns:a16="http://schemas.microsoft.com/office/drawing/2014/main" id="{89526F49-88E5-22D8-2584-72225512F87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24401524"/>
                </p:ext>
              </p:extLst>
            </p:nvPr>
          </p:nvGraphicFramePr>
          <p:xfrm>
            <a:off x="491046" y="3910159"/>
            <a:ext cx="4025334" cy="296127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6" imgW="3957892" imgH="2911341" progId="Prism8.Document">
                    <p:embed/>
                  </p:oleObj>
                </mc:Choice>
                <mc:Fallback>
                  <p:oleObj name="Prism 8" r:id="rId6" imgW="3957892" imgH="2911341" progId="Prism8.Document">
                    <p:embed/>
                    <p:pic>
                      <p:nvPicPr>
                        <p:cNvPr id="11" name="Objet 10">
                          <a:extLst>
                            <a:ext uri="{FF2B5EF4-FFF2-40B4-BE49-F238E27FC236}">
                              <a16:creationId xmlns:a16="http://schemas.microsoft.com/office/drawing/2014/main" id="{89526F49-88E5-22D8-2584-72225512F87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491046" y="3910159"/>
                          <a:ext cx="4025334" cy="296127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418E7E6A-53DF-796C-4991-A283805FA07C}"/>
                </a:ext>
              </a:extLst>
            </p:cNvPr>
            <p:cNvSpPr/>
            <p:nvPr/>
          </p:nvSpPr>
          <p:spPr>
            <a:xfrm flipV="1">
              <a:off x="1553710" y="6109618"/>
              <a:ext cx="2223634" cy="15457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3" name="Groupe 2">
            <a:extLst>
              <a:ext uri="{FF2B5EF4-FFF2-40B4-BE49-F238E27FC236}">
                <a16:creationId xmlns:a16="http://schemas.microsoft.com/office/drawing/2014/main" id="{9F5C5F1D-4132-0925-180C-080963B0D420}"/>
              </a:ext>
            </a:extLst>
          </p:cNvPr>
          <p:cNvGrpSpPr/>
          <p:nvPr/>
        </p:nvGrpSpPr>
        <p:grpSpPr>
          <a:xfrm>
            <a:off x="4740395" y="3885075"/>
            <a:ext cx="3905621" cy="3090144"/>
            <a:chOff x="4757799" y="3753304"/>
            <a:chExt cx="3905621" cy="3090144"/>
          </a:xfrm>
        </p:grpSpPr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16144D6A-A557-8AD5-6A1E-3EAB8E683C2A}"/>
                </a:ext>
              </a:extLst>
            </p:cNvPr>
            <p:cNvSpPr txBox="1"/>
            <p:nvPr/>
          </p:nvSpPr>
          <p:spPr>
            <a:xfrm flipH="1">
              <a:off x="4757799" y="3753304"/>
              <a:ext cx="2190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b="1" dirty="0"/>
                <a:t>c</a:t>
              </a:r>
            </a:p>
          </p:txBody>
        </p:sp>
        <p:graphicFrame>
          <p:nvGraphicFramePr>
            <p:cNvPr id="2" name="Objet 1">
              <a:extLst>
                <a:ext uri="{FF2B5EF4-FFF2-40B4-BE49-F238E27FC236}">
                  <a16:creationId xmlns:a16="http://schemas.microsoft.com/office/drawing/2014/main" id="{DD415509-0458-F9BB-6156-2D5439CDA9A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55480179"/>
                </p:ext>
              </p:extLst>
            </p:nvPr>
          </p:nvGraphicFramePr>
          <p:xfrm>
            <a:off x="4976269" y="3864445"/>
            <a:ext cx="3687151" cy="297900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8" imgW="3918277" imgH="3165894" progId="Prism8.Document">
                    <p:embed/>
                  </p:oleObj>
                </mc:Choice>
                <mc:Fallback>
                  <p:oleObj name="Prism 8" r:id="rId8" imgW="3918277" imgH="3165894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4976269" y="3864445"/>
                          <a:ext cx="3687151" cy="297900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DE216733-728C-358E-4D93-F8969D8E02F8}"/>
                </a:ext>
              </a:extLst>
            </p:cNvPr>
            <p:cNvSpPr/>
            <p:nvPr/>
          </p:nvSpPr>
          <p:spPr>
            <a:xfrm>
              <a:off x="5903202" y="6127588"/>
              <a:ext cx="1915886" cy="13660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aphicFrame>
        <p:nvGraphicFramePr>
          <p:cNvPr id="13" name="Objet 12">
            <a:extLst>
              <a:ext uri="{FF2B5EF4-FFF2-40B4-BE49-F238E27FC236}">
                <a16:creationId xmlns:a16="http://schemas.microsoft.com/office/drawing/2014/main" id="{7F8D6379-71A0-D584-9CEB-7E589B17ADC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84384184"/>
              </p:ext>
            </p:extLst>
          </p:nvPr>
        </p:nvGraphicFramePr>
        <p:xfrm>
          <a:off x="8372475" y="3875088"/>
          <a:ext cx="3503613" cy="30464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0" imgW="3840487" imgH="3337997" progId="Prism8.Document">
                  <p:embed/>
                </p:oleObj>
              </mc:Choice>
              <mc:Fallback>
                <p:oleObj name="Prism 8" r:id="rId10" imgW="3840487" imgH="333799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8372475" y="3875088"/>
                        <a:ext cx="3503613" cy="30464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Rectangle 14">
            <a:extLst>
              <a:ext uri="{FF2B5EF4-FFF2-40B4-BE49-F238E27FC236}">
                <a16:creationId xmlns:a16="http://schemas.microsoft.com/office/drawing/2014/main" id="{B88BECA6-DF36-7224-8897-F1D2CD71D949}"/>
              </a:ext>
            </a:extLst>
          </p:cNvPr>
          <p:cNvSpPr/>
          <p:nvPr/>
        </p:nvSpPr>
        <p:spPr>
          <a:xfrm>
            <a:off x="9318171" y="6253308"/>
            <a:ext cx="1774372" cy="14749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6570654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4">
            <a:extLst>
              <a:ext uri="{FF2B5EF4-FFF2-40B4-BE49-F238E27FC236}">
                <a16:creationId xmlns:a16="http://schemas.microsoft.com/office/drawing/2014/main" id="{682C862D-6BDB-A44B-D478-C21AB224F7D0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546337010"/>
              </p:ext>
            </p:extLst>
          </p:nvPr>
        </p:nvGraphicFramePr>
        <p:xfrm>
          <a:off x="45042" y="678977"/>
          <a:ext cx="12099059" cy="6158220"/>
        </p:xfrm>
        <a:graphic>
          <a:graphicData uri="http://schemas.openxmlformats.org/drawingml/2006/table">
            <a:tbl>
              <a:tblPr firstRow="1" bandRow="1">
                <a:tableStyleId>{F5AB1C69-6EDB-4FF4-983F-18BD219EF322}</a:tableStyleId>
              </a:tblPr>
              <a:tblGrid>
                <a:gridCol w="1897539">
                  <a:extLst>
                    <a:ext uri="{9D8B030D-6E8A-4147-A177-3AD203B41FA5}">
                      <a16:colId xmlns:a16="http://schemas.microsoft.com/office/drawing/2014/main" val="76506641"/>
                    </a:ext>
                  </a:extLst>
                </a:gridCol>
                <a:gridCol w="5100320">
                  <a:extLst>
                    <a:ext uri="{9D8B030D-6E8A-4147-A177-3AD203B41FA5}">
                      <a16:colId xmlns:a16="http://schemas.microsoft.com/office/drawing/2014/main" val="3496149261"/>
                    </a:ext>
                  </a:extLst>
                </a:gridCol>
                <a:gridCol w="5101200">
                  <a:extLst>
                    <a:ext uri="{9D8B030D-6E8A-4147-A177-3AD203B41FA5}">
                      <a16:colId xmlns:a16="http://schemas.microsoft.com/office/drawing/2014/main" val="3807549753"/>
                    </a:ext>
                  </a:extLst>
                </a:gridCol>
              </a:tblGrid>
              <a:tr h="447418">
                <a:tc>
                  <a:txBody>
                    <a:bodyPr/>
                    <a:lstStyle/>
                    <a:p>
                      <a:pPr algn="ctr"/>
                      <a:r>
                        <a:rPr lang="fr-FR" sz="1400" dirty="0">
                          <a:latin typeface="Palatino Linotype" panose="02040502050505030304" pitchFamily="18" charset="0"/>
                        </a:rPr>
                        <a:t> Name of the </a:t>
                      </a:r>
                      <a:r>
                        <a:rPr lang="fr-FR" sz="1400" dirty="0" err="1">
                          <a:latin typeface="Palatino Linotype" panose="02040502050505030304" pitchFamily="18" charset="0"/>
                        </a:rPr>
                        <a:t>oligonucleotide</a:t>
                      </a:r>
                      <a:r>
                        <a:rPr lang="fr-FR" sz="1400" dirty="0">
                          <a:latin typeface="Palatino Linotype" panose="02040502050505030304" pitchFamily="18" charset="0"/>
                        </a:rPr>
                        <a:t>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fr-FR" sz="1400" dirty="0" err="1">
                          <a:latin typeface="Palatino Linotype" panose="02040502050505030304" pitchFamily="18" charset="0"/>
                        </a:rPr>
                        <a:t>Forward</a:t>
                      </a:r>
                      <a:r>
                        <a:rPr lang="fr-FR" sz="1400" dirty="0">
                          <a:latin typeface="Palatino Linotype" panose="02040502050505030304" pitchFamily="18" charset="0"/>
                        </a:rPr>
                        <a:t> primer</a:t>
                      </a:r>
                    </a:p>
                    <a:p>
                      <a:pPr algn="ctr"/>
                      <a:r>
                        <a:rPr lang="fr-FR" sz="1400" dirty="0">
                          <a:latin typeface="Palatino Linotype" panose="02040502050505030304" pitchFamily="18" charset="0"/>
                        </a:rPr>
                        <a:t>5’-3’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>
                          <a:latin typeface="Palatino Linotype" panose="02040502050505030304" pitchFamily="18" charset="0"/>
                        </a:rPr>
                        <a:t>Reverse primer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dirty="0">
                          <a:latin typeface="Palatino Linotype" panose="02040502050505030304" pitchFamily="18" charset="0"/>
                        </a:rPr>
                        <a:t>5’-3’</a:t>
                      </a:r>
                    </a:p>
                    <a:p>
                      <a:pPr algn="ctr"/>
                      <a:endParaRPr lang="fr-FR" sz="14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07907296"/>
                  </a:ext>
                </a:extLst>
              </a:tr>
              <a:tr h="409045">
                <a:tc>
                  <a:txBody>
                    <a:bodyPr/>
                    <a:lstStyle/>
                    <a:p>
                      <a:pPr algn="ctr"/>
                      <a:r>
                        <a:rPr lang="fr-FR" sz="1400" dirty="0">
                          <a:latin typeface="Palatino Linotype" panose="02040502050505030304" pitchFamily="18" charset="0"/>
                        </a:rPr>
                        <a:t>Hsa-HMGA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>
                          <a:latin typeface="Palatino Linotype" panose="02040502050505030304" pitchFamily="18" charset="0"/>
                        </a:rPr>
                        <a:t>AGTCCCTCTAAAGCAGCTCAAAA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>
                          <a:latin typeface="Palatino Linotype" panose="02040502050505030304" pitchFamily="18" charset="0"/>
                        </a:rPr>
                        <a:t>CCATTTCCTAGGTCTGCCT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3016048"/>
                  </a:ext>
                </a:extLst>
              </a:tr>
              <a:tr h="409045">
                <a:tc>
                  <a:txBody>
                    <a:bodyPr/>
                    <a:lstStyle/>
                    <a:p>
                      <a:pPr algn="ctr"/>
                      <a:r>
                        <a:rPr lang="fr-FR" sz="1400" dirty="0">
                          <a:latin typeface="Palatino Linotype" panose="02040502050505030304" pitchFamily="18" charset="0"/>
                        </a:rPr>
                        <a:t>Hsa-SOX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kern="1200" dirty="0">
                          <a:solidFill>
                            <a:schemeClr val="dk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GCTGGAAGCTGCTCAAAGAC</a:t>
                      </a:r>
                      <a:endParaRPr lang="fr-FR" sz="14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kern="1200" dirty="0">
                          <a:solidFill>
                            <a:schemeClr val="dk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CCGACCTTGTCTCCCTTCT</a:t>
                      </a:r>
                      <a:endParaRPr lang="fr-FR" sz="14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91436138"/>
                  </a:ext>
                </a:extLst>
              </a:tr>
              <a:tr h="409045">
                <a:tc>
                  <a:txBody>
                    <a:bodyPr/>
                    <a:lstStyle/>
                    <a:p>
                      <a:pPr algn="ctr"/>
                      <a:r>
                        <a:rPr lang="fr-FR" sz="1400" dirty="0">
                          <a:latin typeface="Palatino Linotype" panose="02040502050505030304" pitchFamily="18" charset="0"/>
                        </a:rPr>
                        <a:t>Hsa-TGFBR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TGCAAGATACATGGCTCCAG</a:t>
                      </a:r>
                      <a:endParaRPr lang="fr-FR" sz="14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CAACACGTTGTCCTTCATGC</a:t>
                      </a:r>
                      <a:endParaRPr lang="fr-FR" sz="14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77670662"/>
                  </a:ext>
                </a:extLst>
              </a:tr>
              <a:tr h="409045">
                <a:tc>
                  <a:txBody>
                    <a:bodyPr/>
                    <a:lstStyle/>
                    <a:p>
                      <a:pPr algn="ctr"/>
                      <a:r>
                        <a:rPr lang="fr-FR" sz="1400" dirty="0">
                          <a:latin typeface="Palatino Linotype" panose="02040502050505030304" pitchFamily="18" charset="0"/>
                        </a:rPr>
                        <a:t>Hsa-SNAI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>
                          <a:latin typeface="Palatino Linotype" panose="02040502050505030304" pitchFamily="18" charset="0"/>
                        </a:rPr>
                        <a:t>CGAGTGGTTCTTCTGCGCT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>
                          <a:latin typeface="Palatino Linotype" panose="02040502050505030304" pitchFamily="18" charset="0"/>
                        </a:rPr>
                        <a:t>CTGCTGGAAGGTAAACTCTGG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5583529"/>
                  </a:ext>
                </a:extLst>
              </a:tr>
              <a:tr h="409045">
                <a:tc>
                  <a:txBody>
                    <a:bodyPr/>
                    <a:lstStyle/>
                    <a:p>
                      <a:pPr algn="ctr"/>
                      <a:r>
                        <a:rPr lang="fr-FR" sz="1400" dirty="0">
                          <a:latin typeface="Palatino Linotype" panose="02040502050505030304" pitchFamily="18" charset="0"/>
                        </a:rPr>
                        <a:t>Hsa-SNAI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TCGGACCCACACATTACCTT</a:t>
                      </a:r>
                      <a:endParaRPr lang="fr-FR" sz="14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TTGGAGCAGTTTTTGCACTG</a:t>
                      </a:r>
                      <a:endParaRPr lang="fr-FR" sz="14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55511494"/>
                  </a:ext>
                </a:extLst>
              </a:tr>
              <a:tr h="409045">
                <a:tc>
                  <a:txBody>
                    <a:bodyPr/>
                    <a:lstStyle/>
                    <a:p>
                      <a:pPr algn="ctr"/>
                      <a:r>
                        <a:rPr lang="fr-FR" sz="1400" dirty="0">
                          <a:latin typeface="Palatino Linotype" panose="02040502050505030304" pitchFamily="18" charset="0"/>
                        </a:rPr>
                        <a:t>Hsa-ZEB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kern="1200" dirty="0">
                          <a:solidFill>
                            <a:schemeClr val="dk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CTACACCGCCCAAAAAGAAA</a:t>
                      </a:r>
                      <a:endParaRPr lang="fr-FR" sz="14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kern="1200" dirty="0">
                          <a:solidFill>
                            <a:schemeClr val="dk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AGCGCTTTCCACATTTGTC</a:t>
                      </a:r>
                      <a:endParaRPr lang="fr-FR" sz="14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87746269"/>
                  </a:ext>
                </a:extLst>
              </a:tr>
              <a:tr h="409045">
                <a:tc>
                  <a:txBody>
                    <a:bodyPr/>
                    <a:lstStyle/>
                    <a:p>
                      <a:pPr algn="ctr"/>
                      <a:r>
                        <a:rPr lang="fr-FR" sz="1400" dirty="0">
                          <a:latin typeface="Palatino Linotype" panose="02040502050505030304" pitchFamily="18" charset="0"/>
                        </a:rPr>
                        <a:t>Hsa-CDH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kern="1200" dirty="0">
                          <a:solidFill>
                            <a:schemeClr val="dk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GCTGAGCTGGACAGGGAGGA</a:t>
                      </a:r>
                      <a:endParaRPr lang="fr-FR" sz="14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kern="1200" dirty="0">
                          <a:solidFill>
                            <a:schemeClr val="dk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TGGGGGCGTTGTCATTCA</a:t>
                      </a:r>
                      <a:endParaRPr lang="fr-FR" sz="14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12277423"/>
                  </a:ext>
                </a:extLst>
              </a:tr>
              <a:tr h="409045">
                <a:tc>
                  <a:txBody>
                    <a:bodyPr/>
                    <a:lstStyle/>
                    <a:p>
                      <a:pPr algn="ctr"/>
                      <a:r>
                        <a:rPr lang="fr-FR" sz="1400" dirty="0">
                          <a:latin typeface="Palatino Linotype" panose="02040502050505030304" pitchFamily="18" charset="0"/>
                        </a:rPr>
                        <a:t>Hsa-TRPM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fr-FR" sz="1400" kern="1200" dirty="0">
                          <a:solidFill>
                            <a:schemeClr val="dk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CCGATGGAGGAAACACGAG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fr-FR" sz="1400" kern="1200" dirty="0">
                          <a:solidFill>
                            <a:schemeClr val="dk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GTCACCCGTATCCTCTCATC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29041127"/>
                  </a:ext>
                </a:extLst>
              </a:tr>
              <a:tr h="409045">
                <a:tc>
                  <a:txBody>
                    <a:bodyPr/>
                    <a:lstStyle/>
                    <a:p>
                      <a:pPr algn="ctr"/>
                      <a:r>
                        <a:rPr lang="fr-FR" sz="1400" dirty="0">
                          <a:latin typeface="Palatino Linotype" panose="02040502050505030304" pitchFamily="18" charset="0"/>
                        </a:rPr>
                        <a:t>Hsa-NEDD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TGACCGGAAAGGAGATTGAGAT</a:t>
                      </a:r>
                      <a:endParaRPr lang="fr-FR" sz="14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CCTCCACACGCTCCTTGATT</a:t>
                      </a:r>
                      <a:endParaRPr lang="fr-FR" sz="14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4926826"/>
                  </a:ext>
                </a:extLst>
              </a:tr>
              <a:tr h="409045">
                <a:tc>
                  <a:txBody>
                    <a:bodyPr/>
                    <a:lstStyle/>
                    <a:p>
                      <a:pPr algn="ctr"/>
                      <a:r>
                        <a:rPr lang="fr-FR" sz="1400" dirty="0">
                          <a:latin typeface="Palatino Linotype" panose="02040502050505030304" pitchFamily="18" charset="0"/>
                        </a:rPr>
                        <a:t>Hsa-TTC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CGGAGAAGCTGTGAGGTTCTTTA</a:t>
                      </a:r>
                      <a:endParaRPr lang="fr-FR" sz="1400" b="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TCCTCTGCAACCCCACAGTT</a:t>
                      </a:r>
                      <a:endParaRPr lang="fr-FR" sz="1400" b="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37395551"/>
                  </a:ext>
                </a:extLst>
              </a:tr>
              <a:tr h="409045">
                <a:tc>
                  <a:txBody>
                    <a:bodyPr/>
                    <a:lstStyle/>
                    <a:p>
                      <a:pPr algn="ctr"/>
                      <a:r>
                        <a:rPr lang="fr-FR" sz="1400" dirty="0">
                          <a:latin typeface="Palatino Linotype" panose="02040502050505030304" pitchFamily="18" charset="0"/>
                        </a:rPr>
                        <a:t>Hsa-HMGA2-WT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CGGGTGAGAAAAACCGAAT </a:t>
                      </a:r>
                      <a:endParaRPr lang="fr-FR" sz="14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TGCTCTGAGGCTGACAAGTG</a:t>
                      </a:r>
                      <a:endParaRPr lang="fr-FR" sz="14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51436969"/>
                  </a:ext>
                </a:extLst>
              </a:tr>
              <a:tr h="409045">
                <a:tc>
                  <a:txBody>
                    <a:bodyPr/>
                    <a:lstStyle/>
                    <a:p>
                      <a:pPr algn="ctr"/>
                      <a:r>
                        <a:rPr lang="fr-FR" sz="1400" dirty="0">
                          <a:latin typeface="Palatino Linotype" panose="02040502050505030304" pitchFamily="18" charset="0"/>
                        </a:rPr>
                        <a:t>Hsa-HMGA2-MUT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0" kern="1200" dirty="0">
                          <a:solidFill>
                            <a:schemeClr val="dk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GGTTATGTTCATTTTTCAAGGAGCGAAGTAAGCAAACAAATATTG</a:t>
                      </a:r>
                      <a:endParaRPr lang="fr-FR" sz="1400" b="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0" kern="1200" dirty="0">
                          <a:solidFill>
                            <a:schemeClr val="dk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CAATATTTGTTTGCTTACTCCCCGCTTTGAAAAATGAACATAACC</a:t>
                      </a:r>
                      <a:endParaRPr lang="fr-FR" sz="1400" b="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13385877"/>
                  </a:ext>
                </a:extLst>
              </a:tr>
              <a:tr h="409045">
                <a:tc>
                  <a:txBody>
                    <a:bodyPr/>
                    <a:lstStyle/>
                    <a:p>
                      <a:pPr algn="ctr"/>
                      <a:r>
                        <a:rPr lang="fr-FR" sz="1400" dirty="0">
                          <a:latin typeface="Palatino Linotype" panose="02040502050505030304" pitchFamily="18" charset="0"/>
                        </a:rPr>
                        <a:t>Mmu-HMGA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b="0" dirty="0">
                          <a:latin typeface="Palatino Linotype" panose="02040502050505030304" pitchFamily="18" charset="0"/>
                        </a:rPr>
                        <a:t>ACATCAGCCCAGGGACAA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b="0" dirty="0">
                          <a:latin typeface="Palatino Linotype" panose="02040502050505030304" pitchFamily="18" charset="0"/>
                        </a:rPr>
                        <a:t>TTCTGGGCTGCTTTAGAGG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72215626"/>
                  </a:ext>
                </a:extLst>
              </a:tr>
            </a:tbl>
          </a:graphicData>
        </a:graphic>
      </p:graphicFrame>
      <p:sp>
        <p:nvSpPr>
          <p:cNvPr id="6" name="ZoneTexte 5">
            <a:extLst>
              <a:ext uri="{FF2B5EF4-FFF2-40B4-BE49-F238E27FC236}">
                <a16:creationId xmlns:a16="http://schemas.microsoft.com/office/drawing/2014/main" id="{312827F1-9DBF-3255-9D13-B974BCFA6DF5}"/>
              </a:ext>
            </a:extLst>
          </p:cNvPr>
          <p:cNvSpPr txBox="1"/>
          <p:nvPr/>
        </p:nvSpPr>
        <p:spPr>
          <a:xfrm>
            <a:off x="2494633" y="0"/>
            <a:ext cx="11311822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100" b="1" dirty="0">
                <a:latin typeface="Palatino Linotype" panose="02040502050505030304" pitchFamily="18" charset="0"/>
              </a:rPr>
              <a:t> Table S1 </a:t>
            </a:r>
          </a:p>
          <a:p>
            <a:pPr algn="just"/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imers sequence</a:t>
            </a:r>
            <a:endParaRPr lang="en-US" sz="1100" b="0" i="0" dirty="0">
              <a:effectLst/>
              <a:latin typeface="Palatino Linotype" panose="02040502050505030304" pitchFamily="18" charset="0"/>
            </a:endParaRPr>
          </a:p>
          <a:p>
            <a:pPr algn="just"/>
            <a:endParaRPr lang="en-US" sz="11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846543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629</TotalTime>
  <Words>520</Words>
  <Application>Microsoft Office PowerPoint</Application>
  <PresentationFormat>Grand écran</PresentationFormat>
  <Paragraphs>58</Paragraphs>
  <Slides>7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7</vt:i4>
      </vt:variant>
    </vt:vector>
  </HeadingPairs>
  <TitlesOfParts>
    <vt:vector size="13" baseType="lpstr">
      <vt:lpstr>Arial</vt:lpstr>
      <vt:lpstr>Calibri</vt:lpstr>
      <vt:lpstr>Calibri Light</vt:lpstr>
      <vt:lpstr>Palatino Linotype</vt:lpstr>
      <vt:lpstr>Thème Office</vt:lpstr>
      <vt:lpstr>Prism 8</vt:lpstr>
      <vt:lpstr>Supplementary materials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material</dc:title>
  <dc:creator>VAN BRANTEGHEM  Cindy</dc:creator>
  <cp:lastModifiedBy>VAN BRANTEGHEM  Cindy</cp:lastModifiedBy>
  <cp:revision>38</cp:revision>
  <dcterms:created xsi:type="dcterms:W3CDTF">2023-04-25T09:04:17Z</dcterms:created>
  <dcterms:modified xsi:type="dcterms:W3CDTF">2023-06-15T15:15:53Z</dcterms:modified>
</cp:coreProperties>
</file>